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70" r:id="rId2"/>
    <p:sldId id="264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94"/>
    <p:restoredTop sz="96327"/>
  </p:normalViewPr>
  <p:slideViewPr>
    <p:cSldViewPr snapToObjects="1">
      <p:cViewPr varScale="1">
        <p:scale>
          <a:sx n="89" d="100"/>
          <a:sy n="89" d="100"/>
        </p:scale>
        <p:origin x="3176" y="168"/>
      </p:cViewPr>
      <p:guideLst>
        <p:guide orient="horz" pos="3312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Objects="1">
      <p:cViewPr varScale="1">
        <p:scale>
          <a:sx n="120" d="100"/>
          <a:sy n="120" d="100"/>
        </p:scale>
        <p:origin x="5032" y="1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086972-B8E0-C24A-B90B-3C85F1B2D5D9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8D49B-7C5F-D443-8A22-2923A6B2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00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E8D49B-7C5F-D443-8A22-2923A6B276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6610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1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4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48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8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04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59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9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9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766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475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901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81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224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897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1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4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060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04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1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E234C7C2-C949-733E-621B-DCA58891C3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891" y="6782410"/>
            <a:ext cx="2743200" cy="312359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CAAEBC5-EAD2-A446-B23A-CC2CF86F27BA}"/>
              </a:ext>
            </a:extLst>
          </p:cNvPr>
          <p:cNvSpPr txBox="1"/>
          <p:nvPr/>
        </p:nvSpPr>
        <p:spPr>
          <a:xfrm>
            <a:off x="1882491" y="27801"/>
            <a:ext cx="2844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4399D6-87A1-1943-9700-8BD7F103AEBB}"/>
              </a:ext>
            </a:extLst>
          </p:cNvPr>
          <p:cNvSpPr txBox="1"/>
          <p:nvPr/>
        </p:nvSpPr>
        <p:spPr>
          <a:xfrm>
            <a:off x="61017" y="156058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852C9E-C2AA-9D4B-8016-10AE6E380A06}"/>
              </a:ext>
            </a:extLst>
          </p:cNvPr>
          <p:cNvSpPr txBox="1"/>
          <p:nvPr/>
        </p:nvSpPr>
        <p:spPr>
          <a:xfrm>
            <a:off x="61017" y="3431807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432B471-DA9A-0F46-B0FA-52FF270172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0390" y="3430656"/>
            <a:ext cx="2072640" cy="15544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E045A78-E027-DD4E-A81A-35BF3E5ED3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8698" y="3430656"/>
            <a:ext cx="3848592" cy="155448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93003495-4A50-844F-8AA2-41060E824AEF}"/>
              </a:ext>
            </a:extLst>
          </p:cNvPr>
          <p:cNvSpPr txBox="1"/>
          <p:nvPr/>
        </p:nvSpPr>
        <p:spPr>
          <a:xfrm>
            <a:off x="61017" y="4889819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5883EC6-AED9-3847-9DF0-77C322C0D13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390" y="5043910"/>
            <a:ext cx="3873500" cy="16256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D156B28-0E27-4C46-B540-C1491D073C7F}"/>
              </a:ext>
            </a:extLst>
          </p:cNvPr>
          <p:cNvSpPr txBox="1"/>
          <p:nvPr/>
        </p:nvSpPr>
        <p:spPr>
          <a:xfrm>
            <a:off x="61017" y="6837851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F7EEA38-B019-B742-A0FC-155CE05DAD10}"/>
              </a:ext>
            </a:extLst>
          </p:cNvPr>
          <p:cNvSpPr txBox="1"/>
          <p:nvPr/>
        </p:nvSpPr>
        <p:spPr>
          <a:xfrm>
            <a:off x="3342363" y="6837850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40BE2458-F255-FD4D-98EE-C10B088CA3E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26792" y="7158835"/>
            <a:ext cx="1433869" cy="164592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7BBBC08-105D-9F45-886A-BA7FB86BC6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13886" y="7158835"/>
            <a:ext cx="1395018" cy="16459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F5E7984-4D9B-164A-AB9F-62E728078D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7830" y="288979"/>
            <a:ext cx="6400800" cy="30976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6255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3DB3A57-0A7F-DCE8-2A6E-9AABBF16ACD5}"/>
              </a:ext>
            </a:extLst>
          </p:cNvPr>
          <p:cNvSpPr txBox="1"/>
          <p:nvPr/>
        </p:nvSpPr>
        <p:spPr>
          <a:xfrm>
            <a:off x="495300" y="1066800"/>
            <a:ext cx="5867400" cy="50040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S1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T-qPCR analysis of the indicated genes in control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gNT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nd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O (sgPtpn2) B16F10 cells treated for 24 h with PBS or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P-values compare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to the control both unde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. Data are the mean ± SEM of n = 4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. 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B)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Cell proliferation assay of control and Ptpn2 KO B16F10 cells incubated for up to 72 h with 100 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and/or 20 ng/ml TNFα. Data are presented as the mean ± SEM of n=3.  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C)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 numbers counting of B16F10 as described treated with PBS or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24 h. Asterisks compare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to the NTC control or the inhibitors to DMSO under the same treatment (PBS or 100ng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Data are presented as the mean ± SEM of n = 3. ***P &lt; 0.001, ****P &lt; 0.0001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D)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T-qPCR analysi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xcl11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cl5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RNA in B16F10 cells incubated for 24 h with PBS or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20 ng/ml TNFα, together with DMSO or 30 µM of the indicated Ptpn2 inhibitors. 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E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ose-response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rves of PTP 9 in MTS Assay. CCD 841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human primary T cells were incubated with DMSO or up to 5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μ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TP 9. Data showed no significance in viable cell percentage up to 5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μ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Data are the mean ± SEM of n = 4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735106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63</TotalTime>
  <Words>287</Words>
  <Application>Microsoft Macintosh PowerPoint</Application>
  <PresentationFormat>A4 Paper (210x297 mm)</PresentationFormat>
  <Paragraphs>1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 zhouting</dc:creator>
  <cp:lastModifiedBy>Rana, Tariq</cp:lastModifiedBy>
  <cp:revision>385</cp:revision>
  <cp:lastPrinted>2022-06-09T01:30:53Z</cp:lastPrinted>
  <dcterms:created xsi:type="dcterms:W3CDTF">2022-03-29T23:12:58Z</dcterms:created>
  <dcterms:modified xsi:type="dcterms:W3CDTF">2022-12-14T19:42:07Z</dcterms:modified>
</cp:coreProperties>
</file>